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91" r:id="rId2"/>
    <p:sldId id="292" r:id="rId3"/>
    <p:sldId id="293" r:id="rId4"/>
    <p:sldId id="294" r:id="rId5"/>
    <p:sldId id="295" r:id="rId6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orient="horz" pos="2704" userDrawn="1">
          <p15:clr>
            <a:srgbClr val="A4A3A4"/>
          </p15:clr>
        </p15:guide>
        <p15:guide id="3" orient="horz" pos="1434" userDrawn="1">
          <p15:clr>
            <a:srgbClr val="A4A3A4"/>
          </p15:clr>
        </p15:guide>
        <p15:guide id="5" pos="884" userDrawn="1">
          <p15:clr>
            <a:srgbClr val="A4A3A4"/>
          </p15:clr>
        </p15:guide>
        <p15:guide id="6" pos="4513" userDrawn="1">
          <p15:clr>
            <a:srgbClr val="A4A3A4"/>
          </p15:clr>
        </p15:guide>
        <p15:guide id="7" pos="567">
          <p15:clr>
            <a:srgbClr val="A4A3A4"/>
          </p15:clr>
        </p15:guide>
        <p15:guide id="8" pos="210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1571EE"/>
    <a:srgbClr val="EE6C15"/>
    <a:srgbClr val="619CFF"/>
    <a:srgbClr val="F8766D"/>
    <a:srgbClr val="00BFC4"/>
    <a:srgbClr val="D7C95D"/>
    <a:srgbClr val="D97AA5"/>
    <a:srgbClr val="00C7FF"/>
    <a:srgbClr val="FF91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012ECD-51FC-41F1-AA8D-1B2483CD663E}" styleName="밝은 스타일 2 - 강조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301B821-A1FF-4177-AEE7-76D212191A09}" styleName="보통 스타일 1 - 강조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367" autoAdjust="0"/>
    <p:restoredTop sz="94660"/>
  </p:normalViewPr>
  <p:slideViewPr>
    <p:cSldViewPr showGuides="1">
      <p:cViewPr varScale="1">
        <p:scale>
          <a:sx n="68" d="100"/>
          <a:sy n="68" d="100"/>
        </p:scale>
        <p:origin x="1614" y="60"/>
      </p:cViewPr>
      <p:guideLst>
        <p:guide orient="horz" pos="2704"/>
        <p:guide orient="horz" pos="1434"/>
        <p:guide pos="884"/>
        <p:guide pos="4513"/>
        <p:guide pos="567"/>
        <p:guide pos="210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DF2DFB-7481-493A-BA16-99A77C399DFF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82EFBB-6D23-43A9-B9D3-B74D6875C8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53417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3891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8176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7703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973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4836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6318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9764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3852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3585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3322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3702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1447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033" y="0"/>
            <a:ext cx="7794609" cy="61740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541119" y="6381328"/>
            <a:ext cx="7053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11 Fig. Comparison results between VFOS and other programs (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DNABarcodes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FreeBarcodes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6991" y="4462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a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94460" y="0"/>
            <a:ext cx="10719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DNABarcodes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dist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3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N=98536, </a:t>
            </a:r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875272" y="0"/>
            <a:ext cx="10719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DNABarcodes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dist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5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N=2857, </a:t>
            </a:r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56361" y="2999770"/>
            <a:ext cx="10987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FreeBarcodes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um_errors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N=17213, </a:t>
            </a:r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841365" y="2999770"/>
            <a:ext cx="10987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FreeBarcodes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um_errors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2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N=178, </a:t>
            </a:r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94252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4736" y="0"/>
            <a:ext cx="7757223" cy="61704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541119" y="6381328"/>
            <a:ext cx="78630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11 Fig. Comparison results between VFOS and other programs (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DNABarcodes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FreeBarcodes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(continued).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26991" y="4462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b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461940" y="0"/>
            <a:ext cx="10719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DNABarcodes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dist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3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N=98536, </a:t>
            </a:r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7373232" y="0"/>
            <a:ext cx="10719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DNABarcodes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dist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5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N=2857, </a:t>
            </a:r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435112" y="2999770"/>
            <a:ext cx="10987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FreeBarcodes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um_errors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N=17213, </a:t>
            </a:r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346404" y="2999770"/>
            <a:ext cx="10987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FreeBarcodes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um_errors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2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N=178, </a:t>
            </a:r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11851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033" y="0"/>
            <a:ext cx="7790064" cy="61704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541119" y="6381328"/>
            <a:ext cx="78630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11 Fig. Comparison results between VFOS and other programs (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DNABarcodes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FreeBarcodes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(continued).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33403" y="4462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c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047800" y="0"/>
            <a:ext cx="10719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DNABarcodes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dist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3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N=98536, </a:t>
            </a:r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981728" y="0"/>
            <a:ext cx="10719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DNABarcodes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dist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5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N=2857, </a:t>
            </a:r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994461" y="2999770"/>
            <a:ext cx="10987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FreeBarcodes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um_errors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N=17213, </a:t>
            </a:r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879465" y="2999770"/>
            <a:ext cx="10987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FreeBarcodes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um_errors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2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N=178, </a:t>
            </a:r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93826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033" y="0"/>
            <a:ext cx="7790064" cy="61704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541119" y="6381328"/>
            <a:ext cx="78630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11 Fig. Comparison results between VFOS and other programs (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DNABarcodes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FreeBarcodes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(continued).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26991" y="4462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d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051768" y="0"/>
            <a:ext cx="10719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DNABarcodes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dist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3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N=98536, </a:t>
            </a:r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917340" y="0"/>
            <a:ext cx="10719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DNABarcodes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dist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5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N=2857, </a:t>
            </a:r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986841" y="2999770"/>
            <a:ext cx="10987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FreeBarcodes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um_errors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N=17213, </a:t>
            </a:r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879465" y="2999770"/>
            <a:ext cx="10987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FreeBarcodes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um_errors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2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N=178, </a:t>
            </a:r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92482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033" y="0"/>
            <a:ext cx="7790064" cy="61704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541119" y="6381328"/>
            <a:ext cx="78630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11 Fig. Comparison results between VFOS and other programs (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DNABarcodes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FreeBarcodes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(continued).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26991" y="4462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e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461940" y="0"/>
            <a:ext cx="10719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DNABarcodes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dist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3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N=98536, </a:t>
            </a:r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373232" y="0"/>
            <a:ext cx="10719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DNABarcodes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dist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5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N=2857, </a:t>
            </a:r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435112" y="2999770"/>
            <a:ext cx="10987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FreeBarcodes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um_errors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N=17213, </a:t>
            </a:r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346404" y="2999770"/>
            <a:ext cx="10987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FreeBarcodes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um_errors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2</a:t>
            </a:r>
          </a:p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N=178, </a:t>
            </a:r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=1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30210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817</TotalTime>
  <Words>352</Words>
  <Application>Microsoft Office PowerPoint</Application>
  <PresentationFormat>On-screen Show (4:3)</PresentationFormat>
  <Paragraphs>7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맑은 고딕</vt:lpstr>
      <vt:lpstr>Arial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연세의료원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양인석(의생명과학부)</dc:creator>
  <cp:lastModifiedBy>Editor</cp:lastModifiedBy>
  <cp:revision>414</cp:revision>
  <dcterms:created xsi:type="dcterms:W3CDTF">2016-11-08T07:30:46Z</dcterms:created>
  <dcterms:modified xsi:type="dcterms:W3CDTF">2021-02-06T15:45:09Z</dcterms:modified>
</cp:coreProperties>
</file>